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30684-D7A6-4ECB-95C5-DE9ACE557E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B6E1A-ACFD-4625-9CA0-315B567590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47B84-A1F1-4750-A001-7988DE9E9E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29D07-440C-4688-8A2A-A6A34E9EEE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25891B-24A6-42C6-BB46-3DC859199D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12A63-0807-4848-BD7C-978D24AC09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F7DD71-2E7A-4211-95A3-5C24669E0E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CCE15-1DC5-4CA1-8BE1-8E78AD3435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E2EE1-995C-45E6-9A9E-3C997CE24A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DF0F4-F197-4BB2-A944-41B7D2733A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21364-9558-41CE-9F6B-C057D8FA66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002CA-2B94-4051-A283-71AAE48CC6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5DAB05-5151-4828-AEF2-D179131A3461}" type="slidenum">
              <a:rPr b="0" lang="pl-PL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5839200" y="9580680"/>
            <a:ext cx="992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2 Tabl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03200" y="1017720"/>
          <a:ext cx="5915160" cy="965160"/>
        </p:xfrm>
        <a:graphic>
          <a:graphicData uri="http://schemas.openxmlformats.org/drawingml/2006/table">
            <a:tbl>
              <a:tblPr/>
              <a:tblGrid>
                <a:gridCol w="1660680"/>
                <a:gridCol w="957240"/>
                <a:gridCol w="1658880"/>
                <a:gridCol w="1638360"/>
              </a:tblGrid>
              <a:tr h="146520">
                <a:tc rowSpan="2">
                  <a:txBody>
                    <a:bodyPr lIns="9000" rIns="9000" tIns="9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ient 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2efda"/>
                    </a:solidFill>
                  </a:tcPr>
                </a:tc>
                <a:tc rowSpan="2">
                  <a:txBody>
                    <a:bodyPr lIns="9000" rIns="9000" tIns="9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HIV-1 DNA (copies/10</a:t>
                      </a:r>
                      <a:r>
                        <a:rPr b="1" lang="es-ES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r>
                        <a:rPr b="1" lang="es-E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PBMCs)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2efda"/>
                    </a:solidFill>
                  </a:tcPr>
                </a:tc>
                <a:tc gridSpan="2">
                  <a:txBody>
                    <a:bodyPr lIns="9000" rIns="9000" tIns="9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-1 RNA copies/ml in culture supernatant of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2efda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20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8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depleted PBMC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 novo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infected Jurkat cell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2efda"/>
                    </a:solidFill>
                  </a:tcPr>
                </a:tc>
              </a:tr>
              <a:tr h="146520"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520"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520"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28T13:38:11Z</dcterms:created>
  <dc:creator>Ania</dc:creator>
  <dc:description/>
  <dc:language>en-US</dc:language>
  <cp:lastModifiedBy>Ania</cp:lastModifiedBy>
  <cp:lastPrinted>2015-06-02T14:17:35Z</cp:lastPrinted>
  <dcterms:modified xsi:type="dcterms:W3CDTF">2015-06-19T08:55:54Z</dcterms:modified>
  <cp:revision>31</cp:revision>
  <dc:subject/>
  <dc:title>PowerPoint Presentation</dc:title>
</cp:coreProperties>
</file>